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media/image1.png" ContentType="image/png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7926E6C-30DC-4C98-A9BC-B1EB4951E152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96C21EC-93E0-45F6-8FFE-2937DA7A3DA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C807F18-E242-4EA0-864A-C6BBFC97200F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84134EE-957F-4CEE-8EAC-A97EB8EFDD13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37011A3-448A-4C6B-AD13-0EB2A5F951AE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290A354-A231-4ED5-9A60-675B2DDF3B31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1D1C14A-A354-44F7-82F2-2E7E3044CB03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E203587-719D-4CCD-892A-E508F8B150E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9C8B43A-9864-471C-8B0E-1B390CA7AA4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DD52512-8071-4B74-8270-9FBE4F5C8D3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47626FD-82BB-4296-B826-162A62E52D98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F6FCB5-49C6-4FB6-9996-9B0CA4AE4DA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de-DE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de-DE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6CE1D7A9-4064-4A57-84A0-76B88D352AE8}" type="slidenum">
              <a:rPr b="0" lang="de-DE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image" Target="../media/image1.png"/><Relationship Id="rId2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1" name=""/>
          <p:cNvGraphicFramePr/>
          <p:nvPr/>
        </p:nvGraphicFramePr>
        <p:xfrm>
          <a:off x="2165400" y="76320"/>
          <a:ext cx="3402000" cy="6691320"/>
        </p:xfrm>
        <a:graphic>
          <a:graphicData uri="http://schemas.openxmlformats.org/drawingml/2006/table">
            <a:tbl>
              <a:tblPr/>
              <a:tblGrid>
                <a:gridCol w="471600"/>
                <a:gridCol w="423720"/>
                <a:gridCol w="533520"/>
                <a:gridCol w="703080"/>
                <a:gridCol w="662040"/>
                <a:gridCol w="608040"/>
              </a:tblGrid>
              <a:tr h="18396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ID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F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-inflorescence-inflorescenc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flowering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6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inflorescence</a:t>
                      </a:r>
                      <a:endParaRPr b="0" lang="en-US" sz="6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91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11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HLH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HLH8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7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e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398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HLH13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90000"/>
                    </a:solidFill>
                  </a:tcPr>
                </a:tc>
              </a:tr>
              <a:tr h="8604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183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BI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30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BH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9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13248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3264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C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04969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467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C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93f5a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78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C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03146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68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C7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c000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00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UNE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24c6e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14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14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a0000"/>
                    </a:solidFill>
                  </a:tcPr>
                </a:tc>
              </a:tr>
              <a:tr h="8604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087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087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56a98"/>
                    </a:solidFill>
                  </a:tcPr>
                </a:tc>
              </a:tr>
              <a:tr h="838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40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 rowSpan="9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ZIP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BF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04968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92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BF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63b54"/>
                    </a:solidFill>
                  </a:tcPr>
                </a:tc>
              </a:tr>
              <a:tr h="8604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5462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ZIP2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83d57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23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ZIP3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c000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429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ZIP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4766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5812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ZIP6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0264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ZO2H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b425f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0397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BF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d4563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792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GA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9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442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 rowSpan="6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CH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442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34e7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604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59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CTH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23349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014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ZF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a597f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198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ZF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17cb2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91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ZF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56997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559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ZF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4374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45072"/>
                    </a:solidFill>
                  </a:tcPr>
                </a:tc>
              </a:tr>
              <a:tr h="8424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57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 rowSpan="11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2H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57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3c56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460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460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1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78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78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7000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5807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IS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d4563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551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DD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436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38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DD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44f71"/>
                    </a:solidFill>
                  </a:tcPr>
                </a:tc>
              </a:tr>
              <a:tr h="8604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773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TZ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17cb2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434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ZAT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9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82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ZAT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3354c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674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ZF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5173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95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ZF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0628c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158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-lik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OL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b415e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012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 rowSpan="26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F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012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86f9e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22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22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8424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67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67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45073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28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28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24c6d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75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75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c5b83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11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11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17cb2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8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8604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615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615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3354c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04968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37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F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6163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F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8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298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F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436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113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RF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4374f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334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DEAR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4364e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677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BP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4722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F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34e70"/>
                    </a:solidFill>
                  </a:tcPr>
                </a:tc>
              </a:tr>
              <a:tr h="8604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52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F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93f5a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4723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F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e4765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d5d86"/>
                    </a:solidFill>
                  </a:tcPr>
                </a:tc>
              </a:tr>
              <a:tr h="838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837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F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56a98"/>
                    </a:solidFill>
                  </a:tcPr>
                </a:tc>
              </a:tr>
              <a:tr h="8604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74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F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9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8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5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123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F1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1638d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616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RF10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34e6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51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SE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c5c83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061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ORA5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d5d85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69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P2.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17cb2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539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P2.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4374f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32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V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4360"/>
                    </a:solidFill>
                  </a:tcPr>
                </a:tc>
              </a:tr>
              <a:tr h="8604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115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INY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b598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f7aae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614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TA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614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624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ATA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75579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0752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 rowSpan="4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RAS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0752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04968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466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466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3c56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723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CL1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a587e"/>
                    </a:solidFill>
                  </a:tcPr>
                </a:tc>
              </a:tr>
              <a:tr h="8424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0753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CL1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4374e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069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MG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MGB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4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594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 rowSpan="5"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omeobox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LH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63a52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54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LH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3b55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97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BEL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63a53"/>
                    </a:solidFill>
                  </a:tcPr>
                </a:tc>
              </a:tr>
              <a:tr h="8604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67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B-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3354c"/>
                    </a:solidFill>
                  </a:tcPr>
                </a:tc>
              </a:tr>
              <a:tr h="85680"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4737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B-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20000"/>
                    </a:solidFill>
                  </a:tcPr>
                </a:tc>
                <a:tc>
                  <a:txBody>
                    <a:bodyPr lIns="1800" rIns="1800" tIns="180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1800" marR="18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</a:tbl>
          </a:graphicData>
        </a:graphic>
      </p:graphicFrame>
      <p:sp>
        <p:nvSpPr>
          <p:cNvPr id="42" name="Textfeld 5"/>
          <p:cNvSpPr/>
          <p:nvPr/>
        </p:nvSpPr>
        <p:spPr>
          <a:xfrm>
            <a:off x="220680" y="106200"/>
            <a:ext cx="949320" cy="3070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de-DE" sz="1400" spc="-1" strike="noStrike">
                <a:solidFill>
                  <a:srgbClr val="000000"/>
                </a:solidFill>
                <a:latin typeface="Arial"/>
                <a:ea typeface="Arial"/>
              </a:rPr>
              <a:t>Fig. S5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graphicFrame>
        <p:nvGraphicFramePr>
          <p:cNvPr id="43" name=""/>
          <p:cNvGraphicFramePr/>
          <p:nvPr/>
        </p:nvGraphicFramePr>
        <p:xfrm>
          <a:off x="5724360" y="34920"/>
          <a:ext cx="3657600" cy="6791400"/>
        </p:xfrm>
        <a:graphic>
          <a:graphicData uri="http://schemas.openxmlformats.org/drawingml/2006/table">
            <a:tbl>
              <a:tblPr/>
              <a:tblGrid>
                <a:gridCol w="675000"/>
                <a:gridCol w="496800"/>
                <a:gridCol w="552240"/>
                <a:gridCol w="695520"/>
                <a:gridCol w="638280"/>
                <a:gridCol w="599760"/>
              </a:tblGrid>
              <a:tr h="22212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Gene ID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gridSpan="2"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F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h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re-inflorescence-inflorescenc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flowering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1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inflorescence-inflorescenc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</a:tr>
              <a:tr h="8604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243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rowSpan="5"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omeobox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B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a415c"/>
                    </a:solidFill>
                  </a:tcPr>
                </a:tc>
              </a:tr>
              <a:tr h="8712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66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B-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a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618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B-1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b5b82"/>
                    </a:solidFill>
                  </a:tcPr>
                </a:tc>
              </a:tr>
              <a:tr h="874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69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B2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5175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508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B2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44f71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69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SF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SF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96fa0"/>
                    </a:solidFill>
                  </a:tcPr>
                </a:tc>
              </a:tr>
              <a:tr h="8712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188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SFA4A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f618a"/>
                    </a:solidFill>
                  </a:tcPr>
                </a:tc>
              </a:tr>
              <a:tr h="8604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6202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SFB2A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425f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60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 rowSpan="5"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TERF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TERF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80000"/>
                    </a:solidFill>
                  </a:tcPr>
                </a:tc>
              </a:tr>
              <a:tr h="8712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81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TERF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ca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55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TERF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50000"/>
                    </a:solidFill>
                  </a:tcPr>
                </a:tc>
              </a:tr>
              <a:tr h="874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462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TERF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b72a4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b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393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TERF3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</a:tr>
              <a:tr h="9036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47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 rowSpan="18"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47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f608a"/>
                    </a:solidFill>
                  </a:tcPr>
                </a:tc>
              </a:tr>
              <a:tr h="8604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097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C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d5d85"/>
                    </a:solidFill>
                  </a:tcPr>
                </a:tc>
              </a:tr>
              <a:tr h="8712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71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0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1672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623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2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5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2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74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76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2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e78ac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3c55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46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3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0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874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49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3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26591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608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3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f608a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673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4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e4765"/>
                    </a:solidFill>
                  </a:tcPr>
                </a:tc>
              </a:tr>
              <a:tr h="8712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87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4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857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5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c5c83"/>
                    </a:solidFill>
                  </a:tcPr>
                </a:tc>
              </a:tr>
              <a:tr h="874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97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5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6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d5e86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32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7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5174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0618b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372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7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9587e"/>
                    </a:solidFill>
                  </a:tcPr>
                </a:tc>
              </a:tr>
              <a:tr h="874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500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7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5385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63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1.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566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AP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5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9036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684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 rowSpan="7"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-lik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684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8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874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1833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EPR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f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55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HHO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de0000"/>
                    </a:solidFill>
                  </a:tcPr>
                </a:tc>
              </a:tr>
              <a:tr h="874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16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EE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a71a2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00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D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4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103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MYBL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712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173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VE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d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0172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 rowSpan="15"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AF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4360"/>
                    </a:solidFill>
                  </a:tcPr>
                </a:tc>
              </a:tr>
              <a:tr h="8604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560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1.1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8712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155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9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2903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9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874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396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3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36692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341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01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f78ac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94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01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76c9b"/>
                    </a:solidFill>
                  </a:tcPr>
                </a:tc>
              </a:tr>
              <a:tr h="874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528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01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694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02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b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36693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74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03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9577c"/>
                    </a:solidFill>
                  </a:tcPr>
                </a:tc>
              </a:tr>
              <a:tr h="8712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1704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03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9587e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040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04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7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74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131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08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b4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22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C08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c436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528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AM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6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76c9b"/>
                    </a:solidFill>
                  </a:tcPr>
                </a:tc>
              </a:tr>
              <a:tr h="874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0569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 rowSpan="4"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CCAAT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F-YA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a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472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F-YA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d5d85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65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F-YA10 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9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</a:tr>
              <a:tr h="874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4764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NF-YB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d5d85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522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 rowSpan="3"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PLATZ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522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1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712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10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10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7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a71a2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327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327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4867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63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WP-RK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763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75579"/>
                    </a:solidFill>
                  </a:tcPr>
                </a:tc>
              </a:tr>
              <a:tr h="874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35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35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3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94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86e9e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1G255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RAV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EM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73b55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412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igma70-lik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SIGE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55174"/>
                    </a:solidFill>
                  </a:tcPr>
                </a:tc>
              </a:tr>
              <a:tr h="874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32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 rowSpan="2"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P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328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83d57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833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TCP11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 w="4320">
                      <a:solidFill>
                        <a:srgbClr val="404040"/>
                      </a:solidFill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4868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712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5627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 rowSpan="10"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RKY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RKY2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 w="4320">
                      <a:solidFill>
                        <a:srgbClr val="404040"/>
                      </a:solidFill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04968"/>
                    </a:solidFill>
                  </a:tcPr>
                </a:tc>
              </a:tr>
              <a:tr h="8604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457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RKY17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4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e8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2332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RKY1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39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93f5a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04969"/>
                    </a:solidFill>
                  </a:tcPr>
                </a:tc>
              </a:tr>
              <a:tr h="8712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025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RKY2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5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a587e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071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RKY2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68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ff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5G241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RKY3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95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5a8ac6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74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3847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RKY3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3f618a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2G464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RKY46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6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436794"/>
                    </a:solidFill>
                  </a:tcPr>
                </a:tc>
              </a:tr>
              <a:tr h="874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4G2381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RKY53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4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f4867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</a:tr>
              <a:tr h="85680"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AT3G564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 vMerge="1">
                  <a:txBody>
                    <a:bodyPr lIns="90000" rIns="90000" tIns="45000" bIns="45000" anchor="t">
                      <a:noAutofit/>
                    </a:bodyPr>
                    <a:p>
                      <a:endParaRPr b="0" lang="en-US" sz="18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t" marL="90000" marR="9000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729fcf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WRKY7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noFill/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0.0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000000"/>
                    </a:solidFill>
                  </a:tcPr>
                </a:tc>
                <a:tc>
                  <a:txBody>
                    <a:bodyPr lIns="2520" rIns="2520" tIns="2520" bIns="0" anchor="ctr">
                      <a:noAutofit/>
                    </a:bodyPr>
                    <a:p>
                      <a:pPr algn="ctr">
                        <a:lnSpc>
                          <a:spcPct val="100000"/>
                        </a:lnSpc>
                        <a:tabLst>
                          <a:tab algn="l" pos="0"/>
                          <a:tab algn="l" pos="914400"/>
                          <a:tab algn="l" pos="1828800"/>
                          <a:tab algn="l" pos="2743200"/>
                          <a:tab algn="l" pos="3657600"/>
                          <a:tab algn="l" pos="4572000"/>
                          <a:tab algn="l" pos="5486400"/>
                          <a:tab algn="l" pos="6400800"/>
                          <a:tab algn="l" pos="7315200"/>
                          <a:tab algn="l" pos="8229600"/>
                          <a:tab algn="l" pos="9144000"/>
                          <a:tab algn="l" pos="10058400"/>
                        </a:tabLst>
                      </a:pPr>
                      <a:r>
                        <a:rPr b="0" lang="de-DE" sz="500" spc="-1" strike="noStrike">
                          <a:solidFill>
                            <a:srgbClr val="000000"/>
                          </a:solidFill>
                          <a:latin typeface="Arial"/>
                          <a:ea typeface="Arial"/>
                        </a:rPr>
                        <a:t>-0.40</a:t>
                      </a:r>
                      <a:endParaRPr b="0" lang="en-US" sz="500" spc="-1" strike="noStrike">
                        <a:solidFill>
                          <a:srgbClr val="000000"/>
                        </a:solidFill>
                        <a:latin typeface="Calibri"/>
                      </a:endParaRPr>
                    </a:p>
                  </a:txBody>
                  <a:tcPr anchor="ctr" marL="2520" marR="2520">
                    <a:lnL>
                      <a:noFill/>
                    </a:lnL>
                    <a:lnR>
                      <a:noFill/>
                    </a:lnR>
                    <a:lnT>
                      <a:noFill/>
                    </a:lnT>
                    <a:lnB>
                      <a:noFill/>
                    </a:lnB>
                    <a:solidFill>
                      <a:srgbClr val="2a415c"/>
                    </a:solidFill>
                  </a:tcPr>
                </a:tc>
              </a:tr>
            </a:tbl>
          </a:graphicData>
        </a:graphic>
      </p:graphicFrame>
      <p:grpSp>
        <p:nvGrpSpPr>
          <p:cNvPr id="44" name="Gruppieren 1"/>
          <p:cNvGrpSpPr/>
          <p:nvPr/>
        </p:nvGrpSpPr>
        <p:grpSpPr>
          <a:xfrm>
            <a:off x="77760" y="6489720"/>
            <a:ext cx="2050920" cy="368280"/>
            <a:chOff x="77760" y="6489720"/>
            <a:chExt cx="2050920" cy="368280"/>
          </a:xfrm>
        </p:grpSpPr>
        <p:grpSp>
          <p:nvGrpSpPr>
            <p:cNvPr id="45" name="Gruppieren 4"/>
            <p:cNvGrpSpPr/>
            <p:nvPr/>
          </p:nvGrpSpPr>
          <p:grpSpPr>
            <a:xfrm>
              <a:off x="162720" y="6489720"/>
              <a:ext cx="1965960" cy="215640"/>
              <a:chOff x="162720" y="6489720"/>
              <a:chExt cx="1965960" cy="215640"/>
            </a:xfrm>
          </p:grpSpPr>
          <p:pic>
            <p:nvPicPr>
              <p:cNvPr id="46" name="Grafik 1" descr=""/>
              <p:cNvPicPr/>
              <p:nvPr/>
            </p:nvPicPr>
            <p:blipFill>
              <a:blip r:embed="rId1"/>
              <a:stretch/>
            </p:blipFill>
            <p:spPr>
              <a:xfrm>
                <a:off x="162720" y="6489720"/>
                <a:ext cx="986400" cy="163800"/>
              </a:xfrm>
              <a:prstGeom prst="rect">
                <a:avLst/>
              </a:prstGeom>
              <a:ln w="0">
                <a:noFill/>
              </a:ln>
            </p:spPr>
          </p:pic>
          <p:sp>
            <p:nvSpPr>
              <p:cNvPr id="47" name="Textfeld 2"/>
              <p:cNvSpPr/>
              <p:nvPr/>
            </p:nvSpPr>
            <p:spPr>
              <a:xfrm>
                <a:off x="1122480" y="6489720"/>
                <a:ext cx="1006200" cy="215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log</a:t>
                </a:r>
                <a:r>
                  <a:rPr b="0" lang="de-DE" sz="7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10</a:t>
                </a:r>
                <a:r>
                  <a:rPr b="0" lang="de-DE" sz="800" spc="-1" strike="noStrike">
                    <a:solidFill>
                      <a:srgbClr val="000000"/>
                    </a:solidFill>
                    <a:latin typeface="Arial"/>
                    <a:ea typeface="Arial"/>
                  </a:rPr>
                  <a:t> fold change</a:t>
                </a:r>
                <a:endParaRPr b="0" lang="en-US" sz="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48" name="Textfeld 2"/>
            <p:cNvSpPr/>
            <p:nvPr/>
          </p:nvSpPr>
          <p:spPr>
            <a:xfrm>
              <a:off x="955080" y="6581520"/>
              <a:ext cx="2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+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49" name="Textfeld 7"/>
            <p:cNvSpPr/>
            <p:nvPr/>
          </p:nvSpPr>
          <p:spPr>
            <a:xfrm>
              <a:off x="77760" y="6561000"/>
              <a:ext cx="246960" cy="2764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de-DE" sz="1200" spc="-1" strike="noStrike">
                  <a:solidFill>
                    <a:srgbClr val="000000"/>
                  </a:solidFill>
                  <a:latin typeface="Arial"/>
                  <a:ea typeface="Arial"/>
                </a:rPr>
                <a:t>-</a:t>
              </a:r>
              <a:endParaRPr b="0" lang="en-US" sz="12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9-11-26T09:06:31Z</dcterms:created>
  <dc:creator>Hossein</dc:creator>
  <dc:description/>
  <dc:language>en-US</dc:language>
  <cp:lastModifiedBy>Hossein</cp:lastModifiedBy>
  <dcterms:modified xsi:type="dcterms:W3CDTF">2020-03-20T15:30:35Z</dcterms:modified>
  <cp:revision>15</cp:revision>
  <dc:subject/>
  <dc:title>PowerPoint-Präsentation</dc:title>
</cp:coreProperties>
</file>